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95.xml" ContentType="application/vnd.openxmlformats-officedocument.presentationml.slideLayout+xml"/>
  <Override PartName="/ppt/media/image12.tif" ContentType="image/tiff"/>
  <Override PartName="/ppt/media/image1.png" ContentType="image/png"/>
  <Override PartName="/ppt/media/image24.png" ContentType="image/png"/>
  <Override PartName="/ppt/media/image10.png" ContentType="image/png"/>
  <Override PartName="/ppt/media/image8.tif" ContentType="image/tiff"/>
  <Override PartName="/ppt/media/image9.tif" ContentType="image/tiff"/>
  <Override PartName="/ppt/media/image11.png" ContentType="image/png"/>
  <Override PartName="/ppt/media/image7.png" ContentType="image/png"/>
  <Override PartName="/ppt/media/image6.png" ContentType="image/png"/>
  <Override PartName="/ppt/media/image5.tif" ContentType="image/tiff"/>
  <Override PartName="/ppt/media/image2.wmf" ContentType="image/x-wmf"/>
  <Override PartName="/ppt/media/image13.png" ContentType="image/png"/>
  <Override PartName="/ppt/media/image4.tif" ContentType="image/tiff"/>
  <Override PartName="/ppt/media/image27.png" ContentType="image/png"/>
  <Override PartName="/ppt/media/image15.png" ContentType="image/png"/>
  <Override PartName="/ppt/media/image25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4.png" ContentType="image/png"/>
  <Override PartName="/ppt/media/image3.png" ContentType="image/png"/>
  <Override PartName="/ppt/media/image2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</p:sldMasterIdLst>
  <p:sldIdLst>
    <p:sldId id="256" r:id="rId15"/>
  </p:sldIdLst>
  <p:sldSz cx="6119813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" Target="slides/slide1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332F8D-837F-4FF3-8665-C68631F7A2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89C6F0-8DB1-4966-97F5-37729405E7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E553D98C-A495-4E92-B44F-9EC23CAF3E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E7C3B74-9A2D-47BA-ABFC-0D4F5CD11D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C6524042-9C05-42CC-99D0-0BA5C553AD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AA08289-52E8-486C-A0A7-C8D16216CF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C342262F-ED5A-4951-9C96-C0455BE34E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01D901D5-C805-4AA0-8782-794D7471EC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259BBE09-CBA6-4160-B22A-FB0C0F019B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21E99051-2E65-4EEE-BA49-91EDFFB399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720098F-D07A-4410-9826-08130BEA7B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A1F949A-8C7A-4E67-9B16-27941116557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A1A5F-242D-415D-88FC-842C6AF974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E57677D-6CAE-48FA-9814-97D6E344A1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095F89A-6A6C-4309-998F-C884879FFB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2154104-9962-41A3-8217-1674752F59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DCA5AA70-11E9-48D1-AECA-F37D67597D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6FB66B5-A69E-432E-A142-D963B14717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0D8ED89-331E-4691-BE46-E300A7ECE0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951C6991-A9E5-4F7F-9872-DE96CE06EA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738A2CB-01E3-4DE8-807B-E45DE526F1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D00EAE2D-1884-4188-B612-073E5B7D69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FBC8FC1-5FBC-418F-9700-E35C608E32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A430A2-1A4D-4446-9527-BCC641B018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16FD9BBB-C3DF-44AA-918D-FAA20F95C6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C615C0BC-3080-4B15-86AC-FA7469615F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3019C8F-A212-43D0-B343-E86212363F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0409BB7-7757-4FEA-87F1-077C9287BE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6F72DF13-7A02-4760-BE19-F3312E14E4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5988D22C-C5E1-4388-9E51-C40FF4B8D2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F772CB3E-E623-4F2E-9F4E-A13366B015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AB30022-BBBD-4035-82B2-8949969603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25CC5F0-0F71-4320-A59A-B0BB18AD55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214DD07-8EF2-44B9-A2B9-AFAF20C0DF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CFE6AA-4149-46E0-BBC8-3B3E7BB55F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C1922814-16CF-4C4D-9878-3C3F5C6496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2BC3FC4-B209-4CE1-9604-54D89E3A31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AB3AEBE-72F9-4B01-A445-D66B7FF00C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4DF69BC0-BB54-436C-A802-6AC775DD7E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E4D02D2-F032-4C1F-A5BE-AA6ED4C65F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FEAB294-708B-44BE-B5EA-E0A50AEB76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3BB7E09-F043-4B3B-B64E-B7D94801E4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3654391-911C-4B26-8D2A-F9B2158DBB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58F2B283-8C54-4831-B1D9-5C3074349F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B2FCA67-77BC-4AF6-A351-720BF9AB3A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FA294EE-0052-4B29-8D4D-1688A7C09B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72049B5-7C92-4B69-B1AC-FD8D2BDFFB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B50A9D67-E02B-4325-9B58-516B0EFAFF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DC99A6F-BB51-44C0-B298-B077DEBC68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0D54688-9EC3-43B0-BBD5-096C768479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0B640A75-E087-4898-9490-1AC298E596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4C10DD8C-FAA9-437A-881D-022BA37CF5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5CB45368-C939-472E-A01D-BA15BB4A88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72F82050-281A-4ABF-8EB1-C00AB1E507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FA7FCFB7-18D5-484D-A961-F4B72C4CB9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8DD367C9-0F38-4ED2-8B3E-DAEF96F72F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D86F1AE-5409-498A-BB33-3183833465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5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5947058D-F802-42BC-AFF7-C0AA594B9A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ABF4D98F-47E2-4A39-9679-ECEE7BEBE2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3D581EEC-4868-42BA-9AF3-07B1068EA2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DB376CE7-3207-4221-B7A5-C7BCB0D95D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151BA132-B706-4CBF-8C5F-78D590927C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1A35D9C4-D5F4-41D6-97E7-0781D6FC94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39A49DD7-D262-43CB-B3F1-28ACC50132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20509AC-4584-4D64-B3D1-5433F2E7C4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5C3EA29-3D01-4EBA-9BC1-8DDE7BE4AC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917ECF0-9D66-4A6A-9112-939D5FC5A2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85C56E4-9D90-4620-9A95-C1B49B1776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B33615-70F9-480B-B4A3-FA6C3ED08F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A60F3C2-569B-492B-B009-D0995D8975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4B5DEB4-B82E-417F-A56C-EF6FD77D15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0FC7018-191E-42A2-AD6D-26F6EC097C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89E5C40-48A6-4709-8AF4-450D66EFF5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21C0781-18B9-478C-A74E-C4575D72F6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F20B147-3912-4299-9B93-3B7127B0E4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A4EDCC5-AF62-40E8-8E59-093298F152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0210361-9B15-43C5-A429-B5BAF982AE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73C70A2-5EBC-484E-A7AE-B3EAE7E66D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5B00A4D-0D2E-4324-99B3-41A98BCA43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FCBD55-7C18-459F-B76D-6E0B3D2C54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E2CF0DF-347F-4A81-B173-03C4EBB9B4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84372B6-953A-4D2E-903F-92F7AA390C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20C806D-2EBB-44E7-B5BF-1288F5FE2E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734250F-85D9-4786-97C1-B1E8323C5F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1A6C0F5-6953-40FB-B467-308EA6E52F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1AE97ED-BB99-4825-9691-C123B0043E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E03A338-02CE-44F5-9454-6990E32593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94FBEA6-C00A-455B-AAE7-D069F499AE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8230B11-C386-4852-AA1C-99946E5A83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07B60A8-76B6-4B16-841A-B61CB1E2C7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98527-C30E-4637-A597-F7F14541C1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1B83AE7-3316-44C9-B313-AFF63427BC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04F0AFD-4D21-48EC-ADBC-98E51E7CF9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3B8DFB1-99C8-4E72-B0BE-EC69A27546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ADFABF8-1192-4D84-895E-6380CD6AE6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BB44532-08D5-4B8E-BFE2-A523F0A8D0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3AC0E24-9949-4067-8690-BBDC9824DD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FA35978-4F23-4D60-A256-98A8B35A36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E63734F-7410-469D-A72D-216ECC4407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3B41188-704C-472F-B64B-47733B92FE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D831606-A9C2-430D-9C94-2C9E377ECC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C38D24-0ADA-40B2-99C3-A68C57E36E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088FFD3-79EF-4551-9A3E-066FE730F2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3EDD823-BDDF-48B6-AC45-737AEB95C4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A5BE523-36C4-45BC-B1FD-D0FC5D80A1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42FC9A4-83FB-4E08-A4B7-23925D1C22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E4EB452-AC69-4961-8024-9F54F0D5B2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B192AAF-1F9D-49FD-ADC2-2FC4DBD2D0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DE2C56C-DB9A-4088-8AC6-6E0BF0D8F2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3898612-E5D3-4382-B0E3-3CCD5AFA15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4F442EF-CF45-497E-8D6B-1DF315C84C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62F00FC-6D11-4C53-9CC0-1387CB1363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A42120-5497-427C-9E87-9E407B5F49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850667E-0CA8-467B-9C50-BE408930D6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D797AF2-23CD-4FEC-ABDD-AB6DB7C2BA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407FBF7-8C35-4FDB-86AD-E7D0EDB582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043035E-F835-4968-A948-A95D94078F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B027DA5-E06A-40C4-9731-C8330CAE75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B3EA32D-103A-4C64-9098-675CFFE284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EB5EA98-5040-46F0-920F-32401BD161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BFEC8A5-AE13-4D31-98F1-311AE29AC8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868F68E-CBEE-49D1-9B32-7C6C824DD9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B293AB7-501B-4F15-B8E7-0624FDF064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93FC6-BE14-4CD7-9056-290BB83E63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26E2452-1FC9-4BB0-9EEB-526E007734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342FEC7-88AF-4DEE-8E81-EF09A5075C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2783ED0-D410-4EC9-9F30-1DD7CB49D9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D43AF8B-BF09-419D-9474-C4FB9D0093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6D73082-F4D8-433D-ACE5-812DBEAFE6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6BB2CBA-87F5-439E-9AF5-031E1125C1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D1FC102-CFE5-4A9B-AB77-66929301AE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01A88C2-2974-4866-850E-42563CAE6F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969B26D-0F04-4985-9AEF-53D143EB34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3B9649B-4F83-4D49-A427-7AFBB5DDA2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CD2B1A-6D06-44F8-AD5A-E57CF73893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6AB21283-A412-41C1-BB7C-13FC7C321E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DFE92E3-741C-4D42-8D4B-5170FCFD33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F9CD09B8-A0B6-4517-B8B8-429C8D7648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A385C92-0325-445E-998F-3E2C646DB3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8A2A67B-F554-49FC-A294-04C4FEE32D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0371350-D962-4527-A864-2089BBD1E9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97E2B944-EDCE-452D-9CA7-86CDB67A8D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17FFBF4-D005-48A9-B022-620B51B988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973D4E94-1183-4528-A38A-F89DB8F270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A248805-7783-49B3-8D7A-15557904D3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74552-89AB-4798-8817-3401BC5FA6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3F00FC1-0B18-4800-9838-C103A8AABD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C31B567-A35C-4848-B907-84F86DFFED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E909B4DF-974E-4674-BDD9-55B5930939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1B3F830F-6CCD-48D9-B7E9-86EBE655B9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1E5B1983-0551-4C77-B122-EA4406FF36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C47FD0E-F5A8-4727-929D-B6F6EA550B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20A21C5-A7ED-4A98-881F-A0946D7871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5853698-5433-4CDA-B4BB-132DBE5BEF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DD0E825-8FC7-4ECB-ACCE-30C98220BF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8EC6B88-A4AE-4A69-8142-112C33B49E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40788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816120" indent="-4082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224000" indent="-81612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06360" y="8475480"/>
            <a:ext cx="14270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90880" y="8475480"/>
            <a:ext cx="19382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386240" y="8475480"/>
            <a:ext cx="14270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4DE8B71-B007-4B4E-8873-554121A08E8C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D89B3FC-872D-4EFC-BFC5-43226F6E2B4E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834E826-3837-492C-BF88-23AD1A3476E4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D28EC6A-A6DC-4BBA-B7C9-3E057C0B746C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PlaceHolder 3"/>
          <p:cNvSpPr>
            <a:spLocks noGrp="1"/>
          </p:cNvSpPr>
          <p:nvPr>
            <p:ph type="dt" idx="37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PlaceHolder 4"/>
          <p:cNvSpPr>
            <a:spLocks noGrp="1"/>
          </p:cNvSpPr>
          <p:nvPr>
            <p:ph type="ftr" idx="38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PlaceHolder 5"/>
          <p:cNvSpPr>
            <a:spLocks noGrp="1"/>
          </p:cNvSpPr>
          <p:nvPr>
            <p:ph type="sldNum" idx="39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5B56A8E-D1F2-419B-A733-EEE34752275B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FADA83-BA31-4E6E-A405-A9505F0D7318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5FC647E-31D9-4264-B2BB-28CAD0892BEB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F76A12D-E507-4C14-865D-E5DB0F70429D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06D51BA-E84E-467E-A8A3-1E5D8AF81876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D27F353-3B9C-40A3-B112-1F97E27FF29E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2EF34ED-EA75-4FA5-9FEE-FDFCBF8B41BD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6C7EC7F-02E5-4219-A55C-BA4C69BAB3BB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B42BA6A-7899-4191-A7D8-316BF3FCD3D1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image" Target="../media/image3.png"/><Relationship Id="rId4" Type="http://schemas.openxmlformats.org/officeDocument/2006/relationships/image" Target="../media/image4.tif"/><Relationship Id="rId5" Type="http://schemas.openxmlformats.org/officeDocument/2006/relationships/image" Target="../media/image5.tif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tif"/><Relationship Id="rId9" Type="http://schemas.openxmlformats.org/officeDocument/2006/relationships/image" Target="../media/image9.tif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tif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0.png"/><Relationship Id="rId29" Type="http://schemas.openxmlformats.org/officeDocument/2006/relationships/slideLayout" Target="../slideLayouts/slideLayout9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3" name="文本框 130"/>
          <p:cNvSpPr/>
          <p:nvPr/>
        </p:nvSpPr>
        <p:spPr>
          <a:xfrm>
            <a:off x="5426280" y="882504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4" name="组合 162"/>
          <p:cNvGrpSpPr/>
          <p:nvPr/>
        </p:nvGrpSpPr>
        <p:grpSpPr>
          <a:xfrm>
            <a:off x="249120" y="147600"/>
            <a:ext cx="4680360" cy="1766880"/>
            <a:chOff x="249120" y="147600"/>
            <a:chExt cx="4680360" cy="1766880"/>
          </a:xfrm>
        </p:grpSpPr>
        <p:sp>
          <p:nvSpPr>
            <p:cNvPr id="535" name="文本框 135"/>
            <p:cNvSpPr/>
            <p:nvPr/>
          </p:nvSpPr>
          <p:spPr>
            <a:xfrm>
              <a:off x="249120" y="14760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36" name="图片 5" descr="CO-CULTURE DAY10 CD45-PE CON 33"/>
            <p:cNvPicPr/>
            <p:nvPr/>
          </p:nvPicPr>
          <p:blipFill>
            <a:blip r:embed="rId1"/>
            <a:stretch/>
          </p:blipFill>
          <p:spPr>
            <a:xfrm>
              <a:off x="755640" y="576000"/>
              <a:ext cx="1079280" cy="108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7" name="图片 162" descr=""/>
            <p:cNvPicPr/>
            <p:nvPr/>
          </p:nvPicPr>
          <p:blipFill>
            <a:blip r:embed="rId2"/>
            <a:stretch/>
          </p:blipFill>
          <p:spPr>
            <a:xfrm>
              <a:off x="3794400" y="465120"/>
              <a:ext cx="971640" cy="129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8" name="文本框 163"/>
            <p:cNvSpPr/>
            <p:nvPr/>
          </p:nvSpPr>
          <p:spPr>
            <a:xfrm>
              <a:off x="3626280" y="67320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9" name="文本框 164"/>
            <p:cNvSpPr/>
            <p:nvPr/>
          </p:nvSpPr>
          <p:spPr>
            <a:xfrm>
              <a:off x="3626280" y="90504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0" name="文本框 165"/>
            <p:cNvSpPr/>
            <p:nvPr/>
          </p:nvSpPr>
          <p:spPr>
            <a:xfrm>
              <a:off x="3626280" y="113508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1" name="文本框 166"/>
            <p:cNvSpPr/>
            <p:nvPr/>
          </p:nvSpPr>
          <p:spPr>
            <a:xfrm>
              <a:off x="3626280" y="136656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2" name="文本框 167"/>
            <p:cNvSpPr/>
            <p:nvPr/>
          </p:nvSpPr>
          <p:spPr>
            <a:xfrm>
              <a:off x="3626280" y="159732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3" name="文本框 168"/>
            <p:cNvSpPr/>
            <p:nvPr/>
          </p:nvSpPr>
          <p:spPr>
            <a:xfrm>
              <a:off x="3785760" y="169596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4" name="文本框 169"/>
            <p:cNvSpPr/>
            <p:nvPr/>
          </p:nvSpPr>
          <p:spPr>
            <a:xfrm>
              <a:off x="4267080" y="1698840"/>
              <a:ext cx="66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5" name="文本框 170"/>
            <p:cNvSpPr/>
            <p:nvPr/>
          </p:nvSpPr>
          <p:spPr>
            <a:xfrm>
              <a:off x="4170600" y="405720"/>
              <a:ext cx="225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6" name="文本框 171"/>
            <p:cNvSpPr/>
            <p:nvPr/>
          </p:nvSpPr>
          <p:spPr>
            <a:xfrm>
              <a:off x="3626280" y="44280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47" name="组 186"/>
            <p:cNvGrpSpPr/>
            <p:nvPr/>
          </p:nvGrpSpPr>
          <p:grpSpPr>
            <a:xfrm>
              <a:off x="4048560" y="591840"/>
              <a:ext cx="466560" cy="42480"/>
              <a:chOff x="4048560" y="591840"/>
              <a:chExt cx="466560" cy="42480"/>
            </a:xfrm>
          </p:grpSpPr>
          <p:sp>
            <p:nvSpPr>
              <p:cNvPr id="548" name="直线连接符 502"/>
              <p:cNvSpPr/>
              <p:nvPr/>
            </p:nvSpPr>
            <p:spPr>
              <a:xfrm>
                <a:off x="4048560" y="591840"/>
                <a:ext cx="4665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9" name="直线连接符 503"/>
              <p:cNvSpPr/>
              <p:nvPr/>
            </p:nvSpPr>
            <p:spPr>
              <a:xfrm>
                <a:off x="4052520" y="591840"/>
                <a:ext cx="0" cy="42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0" name="直线连接符 504"/>
              <p:cNvSpPr/>
              <p:nvPr/>
            </p:nvSpPr>
            <p:spPr>
              <a:xfrm>
                <a:off x="4511160" y="591840"/>
                <a:ext cx="0" cy="42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51" name="Text Box 136"/>
            <p:cNvSpPr/>
            <p:nvPr/>
          </p:nvSpPr>
          <p:spPr>
            <a:xfrm>
              <a:off x="731160" y="576000"/>
              <a:ext cx="42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ff6600"/>
                  </a:solidFill>
                  <a:latin typeface="Times New Roman"/>
                </a:rPr>
                <a:t>CD</a:t>
              </a:r>
              <a:r>
                <a:rPr b="0" lang="zh-CN" sz="800" spc="-1" strike="noStrike">
                  <a:solidFill>
                    <a:srgbClr val="ff6600"/>
                  </a:solidFill>
                  <a:latin typeface="Times New Roman"/>
                  <a:ea typeface="宋体"/>
                </a:rPr>
                <a:t>4</a:t>
              </a:r>
              <a:r>
                <a:rPr b="0" lang="en-US" sz="800" spc="-1" strike="noStrike">
                  <a:solidFill>
                    <a:srgbClr val="ff6600"/>
                  </a:solidFill>
                  <a:latin typeface="Times New Roman"/>
                </a:rPr>
                <a:t>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52" name="组 2"/>
            <p:cNvGrpSpPr/>
            <p:nvPr/>
          </p:nvGrpSpPr>
          <p:grpSpPr>
            <a:xfrm>
              <a:off x="696960" y="1379520"/>
              <a:ext cx="467280" cy="215640"/>
              <a:chOff x="696960" y="1379520"/>
              <a:chExt cx="467280" cy="215640"/>
            </a:xfrm>
          </p:grpSpPr>
          <p:sp>
            <p:nvSpPr>
              <p:cNvPr id="553" name="直线连接符 426"/>
              <p:cNvSpPr/>
              <p:nvPr/>
            </p:nvSpPr>
            <p:spPr>
              <a:xfrm>
                <a:off x="830880" y="1591920"/>
                <a:ext cx="223560" cy="0"/>
              </a:xfrm>
              <a:prstGeom prst="line">
                <a:avLst/>
              </a:prstGeom>
              <a:ln w="381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4" name="文本框 130"/>
              <p:cNvSpPr/>
              <p:nvPr/>
            </p:nvSpPr>
            <p:spPr>
              <a:xfrm>
                <a:off x="696960" y="1379520"/>
                <a:ext cx="467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ffffff"/>
                    </a:solidFill>
                    <a:latin typeface="Times New Roman"/>
                  </a:rPr>
                  <a:t>100u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555" name="文本框 231" descr=""/>
            <p:cNvPicPr/>
            <p:nvPr/>
          </p:nvPicPr>
          <p:blipFill>
            <a:blip r:embed="rId3"/>
            <a:stretch/>
          </p:blipFill>
          <p:spPr>
            <a:xfrm>
              <a:off x="3397680" y="551160"/>
              <a:ext cx="319320" cy="1147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6" name="文本框 108"/>
            <p:cNvSpPr/>
            <p:nvPr/>
          </p:nvSpPr>
          <p:spPr>
            <a:xfrm>
              <a:off x="1751040" y="238320"/>
              <a:ext cx="374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BC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7" name="Text Box 140"/>
            <p:cNvSpPr/>
            <p:nvPr/>
          </p:nvSpPr>
          <p:spPr>
            <a:xfrm>
              <a:off x="2111400" y="411120"/>
              <a:ext cx="12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8" name="Text Box 139"/>
            <p:cNvSpPr/>
            <p:nvPr/>
          </p:nvSpPr>
          <p:spPr>
            <a:xfrm>
              <a:off x="1031760" y="405720"/>
              <a:ext cx="714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9" name="直线连接符 120"/>
            <p:cNvSpPr/>
            <p:nvPr/>
          </p:nvSpPr>
          <p:spPr>
            <a:xfrm>
              <a:off x="765000" y="450720"/>
              <a:ext cx="2251080" cy="0"/>
            </a:xfrm>
            <a:prstGeom prst="line">
              <a:avLst/>
            </a:prstGeom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0" name="文本框 121"/>
            <p:cNvSpPr/>
            <p:nvPr/>
          </p:nvSpPr>
          <p:spPr>
            <a:xfrm>
              <a:off x="1217520" y="1674720"/>
              <a:ext cx="1393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mAGM-S3 co-culture syste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61" name="图片 4" descr="CO-CULTURE DAY10 CD45-PE CON 21"/>
            <p:cNvPicPr/>
            <p:nvPr/>
          </p:nvPicPr>
          <p:blipFill>
            <a:blip r:embed="rId4">
              <a:lum bright="-12000"/>
            </a:blip>
            <a:stretch/>
          </p:blipFill>
          <p:spPr>
            <a:xfrm>
              <a:off x="1946520" y="595080"/>
              <a:ext cx="107928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2" name="文本框 135"/>
            <p:cNvSpPr/>
            <p:nvPr/>
          </p:nvSpPr>
          <p:spPr>
            <a:xfrm>
              <a:off x="3202920" y="147600"/>
              <a:ext cx="31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63" name="组合 163"/>
          <p:cNvGrpSpPr/>
          <p:nvPr/>
        </p:nvGrpSpPr>
        <p:grpSpPr>
          <a:xfrm>
            <a:off x="247680" y="1801800"/>
            <a:ext cx="4933440" cy="1768320"/>
            <a:chOff x="247680" y="1801800"/>
            <a:chExt cx="4933440" cy="1768320"/>
          </a:xfrm>
        </p:grpSpPr>
        <p:pic>
          <p:nvPicPr>
            <p:cNvPr id="564" name="图片 10" descr="20181119 CDH DAY7 CD43 R2- 4"/>
            <p:cNvPicPr/>
            <p:nvPr/>
          </p:nvPicPr>
          <p:blipFill>
            <a:blip r:embed="rId5"/>
            <a:stretch/>
          </p:blipFill>
          <p:spPr>
            <a:xfrm>
              <a:off x="730080" y="2329920"/>
              <a:ext cx="1080720" cy="108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5" name="图片 15" descr=""/>
            <p:cNvPicPr/>
            <p:nvPr/>
          </p:nvPicPr>
          <p:blipFill>
            <a:blip r:embed="rId6"/>
            <a:stretch/>
          </p:blipFill>
          <p:spPr>
            <a:xfrm>
              <a:off x="3797280" y="2101320"/>
              <a:ext cx="971280" cy="1296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6" name="Text Box 3"/>
            <p:cNvSpPr/>
            <p:nvPr/>
          </p:nvSpPr>
          <p:spPr>
            <a:xfrm>
              <a:off x="247680" y="1801800"/>
              <a:ext cx="358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67" name="文本框 200" descr=""/>
            <p:cNvPicPr/>
            <p:nvPr/>
          </p:nvPicPr>
          <p:blipFill>
            <a:blip r:embed="rId7"/>
            <a:stretch/>
          </p:blipFill>
          <p:spPr>
            <a:xfrm>
              <a:off x="3397320" y="2102040"/>
              <a:ext cx="319320" cy="1289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8" name="文本框 222"/>
            <p:cNvSpPr/>
            <p:nvPr/>
          </p:nvSpPr>
          <p:spPr>
            <a:xfrm>
              <a:off x="4149720" y="2082240"/>
              <a:ext cx="428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*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9" name="文本框 223"/>
            <p:cNvSpPr/>
            <p:nvPr/>
          </p:nvSpPr>
          <p:spPr>
            <a:xfrm>
              <a:off x="3794040" y="3322800"/>
              <a:ext cx="60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0" name="文本框 224"/>
            <p:cNvSpPr/>
            <p:nvPr/>
          </p:nvSpPr>
          <p:spPr>
            <a:xfrm>
              <a:off x="4216320" y="3322800"/>
              <a:ext cx="964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71" name="组 227"/>
            <p:cNvGrpSpPr/>
            <p:nvPr/>
          </p:nvGrpSpPr>
          <p:grpSpPr>
            <a:xfrm>
              <a:off x="4054320" y="2290680"/>
              <a:ext cx="438120" cy="34560"/>
              <a:chOff x="4054320" y="2290680"/>
              <a:chExt cx="438120" cy="34560"/>
            </a:xfrm>
          </p:grpSpPr>
          <p:sp>
            <p:nvSpPr>
              <p:cNvPr id="572" name="直线连接符 216"/>
              <p:cNvSpPr/>
              <p:nvPr/>
            </p:nvSpPr>
            <p:spPr>
              <a:xfrm>
                <a:off x="4054320" y="2290680"/>
                <a:ext cx="438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3" name="直线连接符 217"/>
              <p:cNvSpPr/>
              <p:nvPr/>
            </p:nvSpPr>
            <p:spPr>
              <a:xfrm>
                <a:off x="4058640" y="2290680"/>
                <a:ext cx="0" cy="34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4" name="直线连接符 218"/>
              <p:cNvSpPr/>
              <p:nvPr/>
            </p:nvSpPr>
            <p:spPr>
              <a:xfrm>
                <a:off x="4488120" y="2290680"/>
                <a:ext cx="0" cy="34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75" name="文本框 215"/>
            <p:cNvSpPr/>
            <p:nvPr/>
          </p:nvSpPr>
          <p:spPr>
            <a:xfrm>
              <a:off x="1761480" y="1925640"/>
              <a:ext cx="31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H9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6" name="Text Box 139"/>
            <p:cNvSpPr/>
            <p:nvPr/>
          </p:nvSpPr>
          <p:spPr>
            <a:xfrm>
              <a:off x="988560" y="2101320"/>
              <a:ext cx="721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7" name="Text Box 140"/>
            <p:cNvSpPr/>
            <p:nvPr/>
          </p:nvSpPr>
          <p:spPr>
            <a:xfrm>
              <a:off x="2155680" y="2101320"/>
              <a:ext cx="1104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8" name="直线连接符 115"/>
            <p:cNvSpPr/>
            <p:nvPr/>
          </p:nvSpPr>
          <p:spPr>
            <a:xfrm>
              <a:off x="768240" y="2139480"/>
              <a:ext cx="2247840" cy="7560"/>
            </a:xfrm>
            <a:prstGeom prst="line">
              <a:avLst/>
            </a:prstGeom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9" name="直线连接符 109"/>
            <p:cNvSpPr/>
            <p:nvPr/>
          </p:nvSpPr>
          <p:spPr>
            <a:xfrm>
              <a:off x="834840" y="3321000"/>
              <a:ext cx="226440" cy="0"/>
            </a:xfrm>
            <a:prstGeom prst="line">
              <a:avLst/>
            </a:prstGeom>
            <a:ln w="381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0" name="文本框 130"/>
            <p:cNvSpPr/>
            <p:nvPr/>
          </p:nvSpPr>
          <p:spPr>
            <a:xfrm>
              <a:off x="746280" y="3106800"/>
              <a:ext cx="41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50u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1" name="文本框 208"/>
            <p:cNvSpPr/>
            <p:nvPr/>
          </p:nvSpPr>
          <p:spPr>
            <a:xfrm>
              <a:off x="1311480" y="3354480"/>
              <a:ext cx="1221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hemica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defined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yste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2" name="Text Box 136"/>
            <p:cNvSpPr/>
            <p:nvPr/>
          </p:nvSpPr>
          <p:spPr>
            <a:xfrm>
              <a:off x="741960" y="2329920"/>
              <a:ext cx="42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ff6600"/>
                  </a:solidFill>
                  <a:latin typeface="Times New Roman"/>
                </a:rPr>
                <a:t>CD</a:t>
              </a:r>
              <a:r>
                <a:rPr b="0" lang="zh-CN" sz="800" spc="-1" strike="noStrike">
                  <a:solidFill>
                    <a:srgbClr val="ff6600"/>
                  </a:solidFill>
                  <a:latin typeface="Times New Roman"/>
                  <a:ea typeface="宋体"/>
                </a:rPr>
                <a:t>4</a:t>
              </a:r>
              <a:r>
                <a:rPr b="0" lang="en-US" sz="800" spc="-1" strike="noStrike">
                  <a:solidFill>
                    <a:srgbClr val="ff6600"/>
                  </a:solidFill>
                  <a:latin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83" name="组合 35"/>
            <p:cNvGrpSpPr/>
            <p:nvPr/>
          </p:nvGrpSpPr>
          <p:grpSpPr>
            <a:xfrm>
              <a:off x="3563280" y="2091960"/>
              <a:ext cx="286560" cy="1355040"/>
              <a:chOff x="3563280" y="2091960"/>
              <a:chExt cx="286560" cy="1355040"/>
            </a:xfrm>
          </p:grpSpPr>
          <p:sp>
            <p:nvSpPr>
              <p:cNvPr id="584" name="文本框 154"/>
              <p:cNvSpPr/>
              <p:nvPr/>
            </p:nvSpPr>
            <p:spPr>
              <a:xfrm>
                <a:off x="3563280" y="2091960"/>
                <a:ext cx="284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5" name="文本框 155"/>
              <p:cNvSpPr/>
              <p:nvPr/>
            </p:nvSpPr>
            <p:spPr>
              <a:xfrm>
                <a:off x="3617280" y="254772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6" name="文本框 156"/>
              <p:cNvSpPr/>
              <p:nvPr/>
            </p:nvSpPr>
            <p:spPr>
              <a:xfrm>
                <a:off x="3617280" y="300348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7" name="文本框 157"/>
              <p:cNvSpPr/>
              <p:nvPr/>
            </p:nvSpPr>
            <p:spPr>
              <a:xfrm>
                <a:off x="3616920" y="323136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8" name="文本框 154"/>
              <p:cNvSpPr/>
              <p:nvPr/>
            </p:nvSpPr>
            <p:spPr>
              <a:xfrm>
                <a:off x="3617280" y="231948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9" name="文本框 155"/>
              <p:cNvSpPr/>
              <p:nvPr/>
            </p:nvSpPr>
            <p:spPr>
              <a:xfrm>
                <a:off x="3617280" y="277560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590" name="图片 13" descr="20181119 CDH DAY7 CD43 R2+ 16"/>
            <p:cNvPicPr/>
            <p:nvPr/>
          </p:nvPicPr>
          <p:blipFill>
            <a:blip r:embed="rId8"/>
            <a:stretch/>
          </p:blipFill>
          <p:spPr>
            <a:xfrm>
              <a:off x="1946160" y="2325600"/>
              <a:ext cx="1079280" cy="10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1" name="Text Box 3"/>
            <p:cNvSpPr/>
            <p:nvPr/>
          </p:nvSpPr>
          <p:spPr>
            <a:xfrm>
              <a:off x="3201480" y="1801800"/>
              <a:ext cx="358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D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92" name="组合 18"/>
          <p:cNvGrpSpPr/>
          <p:nvPr/>
        </p:nvGrpSpPr>
        <p:grpSpPr>
          <a:xfrm>
            <a:off x="247680" y="3565440"/>
            <a:ext cx="4730760" cy="1690560"/>
            <a:chOff x="247680" y="3565440"/>
            <a:chExt cx="4730760" cy="1690560"/>
          </a:xfrm>
        </p:grpSpPr>
        <p:pic>
          <p:nvPicPr>
            <p:cNvPr id="593" name="图片 11" descr="20181119 CDH DAY7 CD43 R2+ 13"/>
            <p:cNvPicPr/>
            <p:nvPr/>
          </p:nvPicPr>
          <p:blipFill>
            <a:blip r:embed="rId9"/>
            <a:stretch/>
          </p:blipFill>
          <p:spPr>
            <a:xfrm>
              <a:off x="709200" y="4023720"/>
              <a:ext cx="1080360" cy="1081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4" name="图片 16" descr=""/>
            <p:cNvPicPr/>
            <p:nvPr/>
          </p:nvPicPr>
          <p:blipFill>
            <a:blip r:embed="rId10"/>
            <a:stretch/>
          </p:blipFill>
          <p:spPr>
            <a:xfrm>
              <a:off x="3786840" y="3759120"/>
              <a:ext cx="971280" cy="1297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5" name="Text Box 3"/>
            <p:cNvSpPr/>
            <p:nvPr/>
          </p:nvSpPr>
          <p:spPr>
            <a:xfrm>
              <a:off x="247680" y="3565440"/>
              <a:ext cx="359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E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6" name="文本框 208"/>
            <p:cNvSpPr/>
            <p:nvPr/>
          </p:nvSpPr>
          <p:spPr>
            <a:xfrm>
              <a:off x="1311120" y="5040360"/>
              <a:ext cx="1221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hemica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defined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yste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97" name="文本框 195" descr=""/>
            <p:cNvPicPr/>
            <p:nvPr/>
          </p:nvPicPr>
          <p:blipFill>
            <a:blip r:embed="rId11"/>
            <a:stretch/>
          </p:blipFill>
          <p:spPr>
            <a:xfrm>
              <a:off x="3396240" y="3908160"/>
              <a:ext cx="319320" cy="11476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98" name="组合 7"/>
            <p:cNvGrpSpPr/>
            <p:nvPr/>
          </p:nvGrpSpPr>
          <p:grpSpPr>
            <a:xfrm>
              <a:off x="3530880" y="3746160"/>
              <a:ext cx="330120" cy="1350000"/>
              <a:chOff x="3530880" y="3746160"/>
              <a:chExt cx="330120" cy="1350000"/>
            </a:xfrm>
          </p:grpSpPr>
          <p:sp>
            <p:nvSpPr>
              <p:cNvPr id="599" name="文本框 236"/>
              <p:cNvSpPr/>
              <p:nvPr/>
            </p:nvSpPr>
            <p:spPr>
              <a:xfrm>
                <a:off x="3538440" y="3746160"/>
                <a:ext cx="32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0" name="文本框 238"/>
              <p:cNvSpPr/>
              <p:nvPr/>
            </p:nvSpPr>
            <p:spPr>
              <a:xfrm>
                <a:off x="3538440" y="4502520"/>
                <a:ext cx="32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1" name="文本框 239"/>
              <p:cNvSpPr/>
              <p:nvPr/>
            </p:nvSpPr>
            <p:spPr>
              <a:xfrm>
                <a:off x="3538440" y="4880520"/>
                <a:ext cx="32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2" name="文本框 240"/>
              <p:cNvSpPr/>
              <p:nvPr/>
            </p:nvSpPr>
            <p:spPr>
              <a:xfrm>
                <a:off x="3530880" y="4124160"/>
                <a:ext cx="32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03" name="文本框 214"/>
            <p:cNvSpPr/>
            <p:nvPr/>
          </p:nvSpPr>
          <p:spPr>
            <a:xfrm>
              <a:off x="4142160" y="3823560"/>
              <a:ext cx="371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*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4" name="文本框 225"/>
            <p:cNvSpPr/>
            <p:nvPr/>
          </p:nvSpPr>
          <p:spPr>
            <a:xfrm>
              <a:off x="3791880" y="4989600"/>
              <a:ext cx="57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5" name="文本框 226"/>
            <p:cNvSpPr/>
            <p:nvPr/>
          </p:nvSpPr>
          <p:spPr>
            <a:xfrm>
              <a:off x="4205880" y="4977000"/>
              <a:ext cx="77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606" name="组 228"/>
            <p:cNvGrpSpPr/>
            <p:nvPr/>
          </p:nvGrpSpPr>
          <p:grpSpPr>
            <a:xfrm>
              <a:off x="4057920" y="3992040"/>
              <a:ext cx="416880" cy="31680"/>
              <a:chOff x="4057920" y="3992040"/>
              <a:chExt cx="416880" cy="31680"/>
            </a:xfrm>
          </p:grpSpPr>
          <p:sp>
            <p:nvSpPr>
              <p:cNvPr id="607" name="直线连接符 213"/>
              <p:cNvSpPr/>
              <p:nvPr/>
            </p:nvSpPr>
            <p:spPr>
              <a:xfrm>
                <a:off x="4057920" y="3992040"/>
                <a:ext cx="4168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8" name="直线连接符 214"/>
              <p:cNvSpPr/>
              <p:nvPr/>
            </p:nvSpPr>
            <p:spPr>
              <a:xfrm>
                <a:off x="4061880" y="3992040"/>
                <a:ext cx="0" cy="31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9" name="直线连接符 215"/>
              <p:cNvSpPr/>
              <p:nvPr/>
            </p:nvSpPr>
            <p:spPr>
              <a:xfrm>
                <a:off x="4470840" y="3992040"/>
                <a:ext cx="0" cy="3168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10" name="文本框 209"/>
            <p:cNvSpPr/>
            <p:nvPr/>
          </p:nvSpPr>
          <p:spPr>
            <a:xfrm>
              <a:off x="1728360" y="3614040"/>
              <a:ext cx="38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Z-1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1" name="直线连接符 111"/>
            <p:cNvSpPr/>
            <p:nvPr/>
          </p:nvSpPr>
          <p:spPr>
            <a:xfrm>
              <a:off x="835920" y="5011920"/>
              <a:ext cx="226440" cy="0"/>
            </a:xfrm>
            <a:prstGeom prst="line">
              <a:avLst/>
            </a:prstGeom>
            <a:ln w="381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2" name="文本框 130"/>
            <p:cNvSpPr/>
            <p:nvPr/>
          </p:nvSpPr>
          <p:spPr>
            <a:xfrm>
              <a:off x="714600" y="4811760"/>
              <a:ext cx="415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Times New Roman"/>
                </a:rPr>
                <a:t>50u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3" name="Text Box 139"/>
            <p:cNvSpPr/>
            <p:nvPr/>
          </p:nvSpPr>
          <p:spPr>
            <a:xfrm>
              <a:off x="1007280" y="3769920"/>
              <a:ext cx="72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4" name="Text Box 140"/>
            <p:cNvSpPr/>
            <p:nvPr/>
          </p:nvSpPr>
          <p:spPr>
            <a:xfrm>
              <a:off x="2174400" y="3769920"/>
              <a:ext cx="1104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5" name="直线连接符 118"/>
            <p:cNvSpPr/>
            <p:nvPr/>
          </p:nvSpPr>
          <p:spPr>
            <a:xfrm>
              <a:off x="766080" y="3812760"/>
              <a:ext cx="2248560" cy="9360"/>
            </a:xfrm>
            <a:prstGeom prst="line">
              <a:avLst/>
            </a:prstGeom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6" name="Text Box 136"/>
            <p:cNvSpPr/>
            <p:nvPr/>
          </p:nvSpPr>
          <p:spPr>
            <a:xfrm>
              <a:off x="661320" y="4023720"/>
              <a:ext cx="42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ff6600"/>
                  </a:solidFill>
                  <a:latin typeface="Times New Roman"/>
                </a:rPr>
                <a:t>CD</a:t>
              </a:r>
              <a:r>
                <a:rPr b="0" lang="zh-CN" sz="800" spc="-1" strike="noStrike">
                  <a:solidFill>
                    <a:srgbClr val="ff6600"/>
                  </a:solidFill>
                  <a:latin typeface="Times New Roman"/>
                  <a:ea typeface="宋体"/>
                </a:rPr>
                <a:t>4</a:t>
              </a:r>
              <a:r>
                <a:rPr b="0" lang="en-US" sz="800" spc="-1" strike="noStrike">
                  <a:solidFill>
                    <a:srgbClr val="ff6600"/>
                  </a:solidFill>
                  <a:latin typeface="Times New Roman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17" name="图片 14" descr="20181119 CDH DAY7 CD43 R2+ 34"/>
            <p:cNvPicPr/>
            <p:nvPr/>
          </p:nvPicPr>
          <p:blipFill>
            <a:blip r:embed="rId12"/>
            <a:stretch/>
          </p:blipFill>
          <p:spPr>
            <a:xfrm>
              <a:off x="1936440" y="4025880"/>
              <a:ext cx="1078920" cy="10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8" name="Text Box 3"/>
            <p:cNvSpPr/>
            <p:nvPr/>
          </p:nvSpPr>
          <p:spPr>
            <a:xfrm>
              <a:off x="3200760" y="3565440"/>
              <a:ext cx="359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19" name="Text Box 3"/>
          <p:cNvSpPr/>
          <p:nvPr/>
        </p:nvSpPr>
        <p:spPr>
          <a:xfrm>
            <a:off x="217440" y="511488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0" name="图片 18" descr=""/>
          <p:cNvPicPr/>
          <p:nvPr/>
        </p:nvPicPr>
        <p:blipFill>
          <a:blip r:embed="rId13"/>
          <a:stretch/>
        </p:blipFill>
        <p:spPr>
          <a:xfrm>
            <a:off x="2124000" y="5506920"/>
            <a:ext cx="973080" cy="1297080"/>
          </a:xfrm>
          <a:prstGeom prst="rect">
            <a:avLst/>
          </a:prstGeom>
          <a:ln w="0">
            <a:noFill/>
          </a:ln>
        </p:spPr>
      </p:pic>
      <p:pic>
        <p:nvPicPr>
          <p:cNvPr id="621" name="图片 19" descr=""/>
          <p:cNvPicPr/>
          <p:nvPr/>
        </p:nvPicPr>
        <p:blipFill>
          <a:blip r:embed="rId14"/>
          <a:stretch/>
        </p:blipFill>
        <p:spPr>
          <a:xfrm>
            <a:off x="3513240" y="5514840"/>
            <a:ext cx="973080" cy="1227240"/>
          </a:xfrm>
          <a:prstGeom prst="rect">
            <a:avLst/>
          </a:prstGeom>
          <a:ln w="0">
            <a:noFill/>
          </a:ln>
        </p:spPr>
      </p:pic>
      <p:pic>
        <p:nvPicPr>
          <p:cNvPr id="622" name="图片 20" descr=""/>
          <p:cNvPicPr/>
          <p:nvPr/>
        </p:nvPicPr>
        <p:blipFill>
          <a:blip r:embed="rId15"/>
          <a:stretch/>
        </p:blipFill>
        <p:spPr>
          <a:xfrm>
            <a:off x="4959360" y="5546880"/>
            <a:ext cx="971640" cy="1182600"/>
          </a:xfrm>
          <a:prstGeom prst="rect">
            <a:avLst/>
          </a:prstGeom>
          <a:ln w="0">
            <a:noFill/>
          </a:ln>
        </p:spPr>
      </p:pic>
      <p:pic>
        <p:nvPicPr>
          <p:cNvPr id="623" name="图片 25" descr=""/>
          <p:cNvPicPr/>
          <p:nvPr/>
        </p:nvPicPr>
        <p:blipFill>
          <a:blip r:embed="rId16"/>
          <a:stretch/>
        </p:blipFill>
        <p:spPr>
          <a:xfrm>
            <a:off x="798480" y="5506920"/>
            <a:ext cx="973080" cy="1297080"/>
          </a:xfrm>
          <a:prstGeom prst="rect">
            <a:avLst/>
          </a:prstGeom>
          <a:ln w="0">
            <a:noFill/>
          </a:ln>
        </p:spPr>
      </p:pic>
      <p:pic>
        <p:nvPicPr>
          <p:cNvPr id="624" name="文本框 26" descr=""/>
          <p:cNvPicPr/>
          <p:nvPr/>
        </p:nvPicPr>
        <p:blipFill>
          <a:blip r:embed="rId17"/>
          <a:stretch/>
        </p:blipFill>
        <p:spPr>
          <a:xfrm>
            <a:off x="343080" y="5334120"/>
            <a:ext cx="317160" cy="1641240"/>
          </a:xfrm>
          <a:prstGeom prst="rect">
            <a:avLst/>
          </a:prstGeom>
          <a:ln w="0">
            <a:noFill/>
          </a:ln>
        </p:spPr>
      </p:pic>
      <p:sp>
        <p:nvSpPr>
          <p:cNvPr id="625" name="文本框 222"/>
          <p:cNvSpPr/>
          <p:nvPr/>
        </p:nvSpPr>
        <p:spPr>
          <a:xfrm>
            <a:off x="1130400" y="5424480"/>
            <a:ext cx="428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Times New Roman"/>
                <a:ea typeface="宋体"/>
              </a:rPr>
              <a:t>*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6" name="文本框 223"/>
          <p:cNvSpPr/>
          <p:nvPr/>
        </p:nvSpPr>
        <p:spPr>
          <a:xfrm>
            <a:off x="774720" y="6667560"/>
            <a:ext cx="60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r>
              <a:rPr b="0" lang="zh-CN" sz="8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27" name="组 227"/>
          <p:cNvGrpSpPr/>
          <p:nvPr/>
        </p:nvGrpSpPr>
        <p:grpSpPr>
          <a:xfrm>
            <a:off x="1035000" y="5607000"/>
            <a:ext cx="438120" cy="34920"/>
            <a:chOff x="1035000" y="5607000"/>
            <a:chExt cx="438120" cy="34920"/>
          </a:xfrm>
        </p:grpSpPr>
        <p:sp>
          <p:nvSpPr>
            <p:cNvPr id="628" name="直线连接符 216"/>
            <p:cNvSpPr/>
            <p:nvPr/>
          </p:nvSpPr>
          <p:spPr>
            <a:xfrm>
              <a:off x="1035000" y="5607000"/>
              <a:ext cx="438120" cy="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9" name="直线连接符 217"/>
            <p:cNvSpPr/>
            <p:nvPr/>
          </p:nvSpPr>
          <p:spPr>
            <a:xfrm>
              <a:off x="1039320" y="560700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0" name="直线连接符 218"/>
            <p:cNvSpPr/>
            <p:nvPr/>
          </p:nvSpPr>
          <p:spPr>
            <a:xfrm>
              <a:off x="1468800" y="560700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31" name="组合 33"/>
          <p:cNvGrpSpPr/>
          <p:nvPr/>
        </p:nvGrpSpPr>
        <p:grpSpPr>
          <a:xfrm>
            <a:off x="476280" y="5495760"/>
            <a:ext cx="385560" cy="1255680"/>
            <a:chOff x="476280" y="5495760"/>
            <a:chExt cx="385560" cy="1255680"/>
          </a:xfrm>
        </p:grpSpPr>
        <p:sp>
          <p:nvSpPr>
            <p:cNvPr id="632" name="文本框 155"/>
            <p:cNvSpPr/>
            <p:nvPr/>
          </p:nvSpPr>
          <p:spPr>
            <a:xfrm>
              <a:off x="509760" y="5893200"/>
              <a:ext cx="352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6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3" name="文本框 156"/>
            <p:cNvSpPr/>
            <p:nvPr/>
          </p:nvSpPr>
          <p:spPr>
            <a:xfrm>
              <a:off x="509760" y="6321240"/>
              <a:ext cx="352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4" name="文本框 157"/>
            <p:cNvSpPr/>
            <p:nvPr/>
          </p:nvSpPr>
          <p:spPr>
            <a:xfrm>
              <a:off x="621360" y="6535800"/>
              <a:ext cx="240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5" name="文本框 154"/>
            <p:cNvSpPr/>
            <p:nvPr/>
          </p:nvSpPr>
          <p:spPr>
            <a:xfrm>
              <a:off x="476280" y="5495760"/>
              <a:ext cx="385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0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6" name="文本框 154"/>
            <p:cNvSpPr/>
            <p:nvPr/>
          </p:nvSpPr>
          <p:spPr>
            <a:xfrm>
              <a:off x="527040" y="5694120"/>
              <a:ext cx="334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8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7" name="文本框 155"/>
            <p:cNvSpPr/>
            <p:nvPr/>
          </p:nvSpPr>
          <p:spPr>
            <a:xfrm>
              <a:off x="509760" y="6107400"/>
              <a:ext cx="352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4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38" name="文本框 226"/>
          <p:cNvSpPr/>
          <p:nvPr/>
        </p:nvSpPr>
        <p:spPr>
          <a:xfrm>
            <a:off x="1168560" y="6667560"/>
            <a:ext cx="772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R-spondin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9" name="文本框 42" descr=""/>
          <p:cNvPicPr/>
          <p:nvPr/>
        </p:nvPicPr>
        <p:blipFill>
          <a:blip r:embed="rId18"/>
          <a:stretch/>
        </p:blipFill>
        <p:spPr>
          <a:xfrm>
            <a:off x="1711440" y="5216400"/>
            <a:ext cx="318960" cy="1876680"/>
          </a:xfrm>
          <a:prstGeom prst="rect">
            <a:avLst/>
          </a:prstGeom>
          <a:ln w="0">
            <a:noFill/>
          </a:ln>
        </p:spPr>
      </p:pic>
      <p:sp>
        <p:nvSpPr>
          <p:cNvPr id="640" name="文本框 222"/>
          <p:cNvSpPr/>
          <p:nvPr/>
        </p:nvSpPr>
        <p:spPr>
          <a:xfrm>
            <a:off x="2443320" y="5429160"/>
            <a:ext cx="428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Times New Roman"/>
                <a:ea typeface="宋体"/>
              </a:rPr>
              <a:t>*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1" name="文本框 223"/>
          <p:cNvSpPr/>
          <p:nvPr/>
        </p:nvSpPr>
        <p:spPr>
          <a:xfrm>
            <a:off x="2087640" y="6667560"/>
            <a:ext cx="60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r>
              <a:rPr b="0" lang="zh-CN" sz="8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2" name="组 227"/>
          <p:cNvGrpSpPr/>
          <p:nvPr/>
        </p:nvGrpSpPr>
        <p:grpSpPr>
          <a:xfrm>
            <a:off x="2347920" y="5611680"/>
            <a:ext cx="438120" cy="34920"/>
            <a:chOff x="2347920" y="5611680"/>
            <a:chExt cx="438120" cy="34920"/>
          </a:xfrm>
        </p:grpSpPr>
        <p:sp>
          <p:nvSpPr>
            <p:cNvPr id="643" name="直线连接符 216"/>
            <p:cNvSpPr/>
            <p:nvPr/>
          </p:nvSpPr>
          <p:spPr>
            <a:xfrm>
              <a:off x="2347920" y="5611680"/>
              <a:ext cx="438120" cy="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4" name="直线连接符 217"/>
            <p:cNvSpPr/>
            <p:nvPr/>
          </p:nvSpPr>
          <p:spPr>
            <a:xfrm>
              <a:off x="2352240" y="561168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5" name="直线连接符 218"/>
            <p:cNvSpPr/>
            <p:nvPr/>
          </p:nvSpPr>
          <p:spPr>
            <a:xfrm>
              <a:off x="2781720" y="561168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46" name="组合 88"/>
          <p:cNvGrpSpPr/>
          <p:nvPr/>
        </p:nvGrpSpPr>
        <p:grpSpPr>
          <a:xfrm>
            <a:off x="1798560" y="5500800"/>
            <a:ext cx="385920" cy="1255680"/>
            <a:chOff x="1798560" y="5500800"/>
            <a:chExt cx="385920" cy="1255680"/>
          </a:xfrm>
        </p:grpSpPr>
        <p:sp>
          <p:nvSpPr>
            <p:cNvPr id="647" name="文本框 155"/>
            <p:cNvSpPr/>
            <p:nvPr/>
          </p:nvSpPr>
          <p:spPr>
            <a:xfrm>
              <a:off x="1832040" y="5750280"/>
              <a:ext cx="352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3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8" name="文本框 156"/>
            <p:cNvSpPr/>
            <p:nvPr/>
          </p:nvSpPr>
          <p:spPr>
            <a:xfrm>
              <a:off x="1832040" y="6277320"/>
              <a:ext cx="352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9" name="文本框 157"/>
            <p:cNvSpPr/>
            <p:nvPr/>
          </p:nvSpPr>
          <p:spPr>
            <a:xfrm>
              <a:off x="1943640" y="6540840"/>
              <a:ext cx="240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0" name="文本框 154"/>
            <p:cNvSpPr/>
            <p:nvPr/>
          </p:nvSpPr>
          <p:spPr>
            <a:xfrm>
              <a:off x="1798560" y="5500800"/>
              <a:ext cx="385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4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1" name="文本框 155"/>
            <p:cNvSpPr/>
            <p:nvPr/>
          </p:nvSpPr>
          <p:spPr>
            <a:xfrm>
              <a:off x="1832040" y="6013800"/>
              <a:ext cx="352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52" name="文本框 226"/>
          <p:cNvSpPr/>
          <p:nvPr/>
        </p:nvSpPr>
        <p:spPr>
          <a:xfrm>
            <a:off x="2481120" y="6667560"/>
            <a:ext cx="77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R-spondin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3" name="文本框 57" descr=""/>
          <p:cNvPicPr/>
          <p:nvPr/>
        </p:nvPicPr>
        <p:blipFill>
          <a:blip r:embed="rId19"/>
          <a:stretch/>
        </p:blipFill>
        <p:spPr>
          <a:xfrm>
            <a:off x="3083040" y="5334120"/>
            <a:ext cx="320400" cy="1641240"/>
          </a:xfrm>
          <a:prstGeom prst="rect">
            <a:avLst/>
          </a:prstGeom>
          <a:ln w="0">
            <a:noFill/>
          </a:ln>
        </p:spPr>
      </p:pic>
      <p:sp>
        <p:nvSpPr>
          <p:cNvPr id="654" name="文本框 222"/>
          <p:cNvSpPr/>
          <p:nvPr/>
        </p:nvSpPr>
        <p:spPr>
          <a:xfrm>
            <a:off x="3855960" y="5478480"/>
            <a:ext cx="4287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Times New Roman"/>
                <a:ea typeface="宋体"/>
              </a:rPr>
              <a:t>*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5" name="文本框 223"/>
          <p:cNvSpPr/>
          <p:nvPr/>
        </p:nvSpPr>
        <p:spPr>
          <a:xfrm>
            <a:off x="3500280" y="6667560"/>
            <a:ext cx="606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r>
              <a:rPr b="0" lang="zh-CN" sz="8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56" name="组 227"/>
          <p:cNvGrpSpPr/>
          <p:nvPr/>
        </p:nvGrpSpPr>
        <p:grpSpPr>
          <a:xfrm>
            <a:off x="3760920" y="5661000"/>
            <a:ext cx="438120" cy="34920"/>
            <a:chOff x="3760920" y="5661000"/>
            <a:chExt cx="438120" cy="34920"/>
          </a:xfrm>
        </p:grpSpPr>
        <p:sp>
          <p:nvSpPr>
            <p:cNvPr id="657" name="直线连接符 216"/>
            <p:cNvSpPr/>
            <p:nvPr/>
          </p:nvSpPr>
          <p:spPr>
            <a:xfrm>
              <a:off x="3760920" y="5661000"/>
              <a:ext cx="438120" cy="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8" name="直线连接符 217"/>
            <p:cNvSpPr/>
            <p:nvPr/>
          </p:nvSpPr>
          <p:spPr>
            <a:xfrm>
              <a:off x="3765240" y="566100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9" name="直线连接符 218"/>
            <p:cNvSpPr/>
            <p:nvPr/>
          </p:nvSpPr>
          <p:spPr>
            <a:xfrm>
              <a:off x="4194720" y="566100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60" name="组合 89"/>
          <p:cNvGrpSpPr/>
          <p:nvPr/>
        </p:nvGrpSpPr>
        <p:grpSpPr>
          <a:xfrm>
            <a:off x="3235320" y="5504040"/>
            <a:ext cx="352440" cy="1296360"/>
            <a:chOff x="3235320" y="5504040"/>
            <a:chExt cx="352440" cy="1296360"/>
          </a:xfrm>
        </p:grpSpPr>
        <p:sp>
          <p:nvSpPr>
            <p:cNvPr id="661" name="文本框 155"/>
            <p:cNvSpPr/>
            <p:nvPr/>
          </p:nvSpPr>
          <p:spPr>
            <a:xfrm>
              <a:off x="3235320" y="5764320"/>
              <a:ext cx="352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6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2" name="文本框 156"/>
            <p:cNvSpPr/>
            <p:nvPr/>
          </p:nvSpPr>
          <p:spPr>
            <a:xfrm>
              <a:off x="3235320" y="6311520"/>
              <a:ext cx="352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3" name="文本框 157"/>
            <p:cNvSpPr/>
            <p:nvPr/>
          </p:nvSpPr>
          <p:spPr>
            <a:xfrm>
              <a:off x="3346920" y="6584760"/>
              <a:ext cx="240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4" name="文本框 154"/>
            <p:cNvSpPr/>
            <p:nvPr/>
          </p:nvSpPr>
          <p:spPr>
            <a:xfrm>
              <a:off x="3243600" y="5504040"/>
              <a:ext cx="335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8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5" name="文本框 155"/>
            <p:cNvSpPr/>
            <p:nvPr/>
          </p:nvSpPr>
          <p:spPr>
            <a:xfrm>
              <a:off x="3235320" y="6037560"/>
              <a:ext cx="352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4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66" name="文本框 226"/>
          <p:cNvSpPr/>
          <p:nvPr/>
        </p:nvSpPr>
        <p:spPr>
          <a:xfrm>
            <a:off x="3894120" y="6667560"/>
            <a:ext cx="77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R-spondin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7" name="文本框 72" descr=""/>
          <p:cNvPicPr/>
          <p:nvPr/>
        </p:nvPicPr>
        <p:blipFill>
          <a:blip r:embed="rId20"/>
          <a:stretch/>
        </p:blipFill>
        <p:spPr>
          <a:xfrm>
            <a:off x="4538520" y="5086440"/>
            <a:ext cx="319320" cy="2136600"/>
          </a:xfrm>
          <a:prstGeom prst="rect">
            <a:avLst/>
          </a:prstGeom>
          <a:ln w="0">
            <a:noFill/>
          </a:ln>
        </p:spPr>
      </p:pic>
      <p:sp>
        <p:nvSpPr>
          <p:cNvPr id="668" name="文本框 222"/>
          <p:cNvSpPr/>
          <p:nvPr/>
        </p:nvSpPr>
        <p:spPr>
          <a:xfrm>
            <a:off x="5218200" y="5448240"/>
            <a:ext cx="428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700" spc="-1" strike="noStrike">
                <a:solidFill>
                  <a:srgbClr val="000000"/>
                </a:solidFill>
                <a:latin typeface="Times New Roman"/>
                <a:ea typeface="宋体"/>
              </a:rPr>
              <a:t>*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9" name="文本框 223"/>
          <p:cNvSpPr/>
          <p:nvPr/>
        </p:nvSpPr>
        <p:spPr>
          <a:xfrm>
            <a:off x="4924440" y="6667560"/>
            <a:ext cx="606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r>
              <a:rPr b="0" lang="zh-CN" sz="8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70" name="组 227"/>
          <p:cNvGrpSpPr/>
          <p:nvPr/>
        </p:nvGrpSpPr>
        <p:grpSpPr>
          <a:xfrm>
            <a:off x="5184720" y="5635800"/>
            <a:ext cx="438120" cy="34920"/>
            <a:chOff x="5184720" y="5635800"/>
            <a:chExt cx="438120" cy="34920"/>
          </a:xfrm>
        </p:grpSpPr>
        <p:sp>
          <p:nvSpPr>
            <p:cNvPr id="671" name="直线连接符 216"/>
            <p:cNvSpPr/>
            <p:nvPr/>
          </p:nvSpPr>
          <p:spPr>
            <a:xfrm>
              <a:off x="5184720" y="5635800"/>
              <a:ext cx="438120" cy="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2" name="直线连接符 217"/>
            <p:cNvSpPr/>
            <p:nvPr/>
          </p:nvSpPr>
          <p:spPr>
            <a:xfrm>
              <a:off x="5189040" y="563580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3" name="直线连接符 218"/>
            <p:cNvSpPr/>
            <p:nvPr/>
          </p:nvSpPr>
          <p:spPr>
            <a:xfrm>
              <a:off x="5618520" y="5635800"/>
              <a:ext cx="0" cy="34920"/>
            </a:xfrm>
            <a:prstGeom prst="line">
              <a:avLst/>
            </a:prstGeom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74" name="文本框 226"/>
          <p:cNvSpPr/>
          <p:nvPr/>
        </p:nvSpPr>
        <p:spPr>
          <a:xfrm>
            <a:off x="5318280" y="6667560"/>
            <a:ext cx="772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R-spondin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75" name="组合 94"/>
          <p:cNvGrpSpPr/>
          <p:nvPr/>
        </p:nvGrpSpPr>
        <p:grpSpPr>
          <a:xfrm>
            <a:off x="4624560" y="5526000"/>
            <a:ext cx="385560" cy="1255680"/>
            <a:chOff x="4624560" y="5526000"/>
            <a:chExt cx="385560" cy="1255680"/>
          </a:xfrm>
        </p:grpSpPr>
        <p:sp>
          <p:nvSpPr>
            <p:cNvPr id="676" name="文本框 155"/>
            <p:cNvSpPr/>
            <p:nvPr/>
          </p:nvSpPr>
          <p:spPr>
            <a:xfrm>
              <a:off x="4658040" y="5775480"/>
              <a:ext cx="352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3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7" name="文本框 156"/>
            <p:cNvSpPr/>
            <p:nvPr/>
          </p:nvSpPr>
          <p:spPr>
            <a:xfrm>
              <a:off x="4658040" y="6302520"/>
              <a:ext cx="352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8" name="文本框 157"/>
            <p:cNvSpPr/>
            <p:nvPr/>
          </p:nvSpPr>
          <p:spPr>
            <a:xfrm>
              <a:off x="4769640" y="6566040"/>
              <a:ext cx="240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9" name="文本框 154"/>
            <p:cNvSpPr/>
            <p:nvPr/>
          </p:nvSpPr>
          <p:spPr>
            <a:xfrm>
              <a:off x="4624560" y="5526000"/>
              <a:ext cx="38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4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0" name="文本框 155"/>
            <p:cNvSpPr/>
            <p:nvPr/>
          </p:nvSpPr>
          <p:spPr>
            <a:xfrm>
              <a:off x="4658040" y="6039000"/>
              <a:ext cx="352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81" name="Text Box 3"/>
          <p:cNvSpPr/>
          <p:nvPr/>
        </p:nvSpPr>
        <p:spPr>
          <a:xfrm>
            <a:off x="247680" y="6961320"/>
            <a:ext cx="235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82" name="组合 187"/>
          <p:cNvGrpSpPr/>
          <p:nvPr/>
        </p:nvGrpSpPr>
        <p:grpSpPr>
          <a:xfrm>
            <a:off x="330120" y="7013520"/>
            <a:ext cx="5749560" cy="2136960"/>
            <a:chOff x="330120" y="7013520"/>
            <a:chExt cx="5749560" cy="2136960"/>
          </a:xfrm>
        </p:grpSpPr>
        <p:pic>
          <p:nvPicPr>
            <p:cNvPr id="683" name="图片 21" descr=""/>
            <p:cNvPicPr/>
            <p:nvPr/>
          </p:nvPicPr>
          <p:blipFill>
            <a:blip r:embed="rId21"/>
            <a:stretch/>
          </p:blipFill>
          <p:spPr>
            <a:xfrm>
              <a:off x="745200" y="7434000"/>
              <a:ext cx="971640" cy="129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4" name="图片 22" descr=""/>
            <p:cNvPicPr/>
            <p:nvPr/>
          </p:nvPicPr>
          <p:blipFill>
            <a:blip r:embed="rId22"/>
            <a:stretch/>
          </p:blipFill>
          <p:spPr>
            <a:xfrm>
              <a:off x="2081880" y="7434000"/>
              <a:ext cx="971640" cy="129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5" name="图片 23" descr=""/>
            <p:cNvPicPr/>
            <p:nvPr/>
          </p:nvPicPr>
          <p:blipFill>
            <a:blip r:embed="rId23"/>
            <a:stretch/>
          </p:blipFill>
          <p:spPr>
            <a:xfrm>
              <a:off x="3489120" y="7439400"/>
              <a:ext cx="972360" cy="118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6" name="图片 24" descr=""/>
            <p:cNvPicPr/>
            <p:nvPr/>
          </p:nvPicPr>
          <p:blipFill>
            <a:blip r:embed="rId24"/>
            <a:stretch/>
          </p:blipFill>
          <p:spPr>
            <a:xfrm>
              <a:off x="4925160" y="7439400"/>
              <a:ext cx="971640" cy="118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7" name="文本框 101" descr=""/>
            <p:cNvPicPr/>
            <p:nvPr/>
          </p:nvPicPr>
          <p:blipFill>
            <a:blip r:embed="rId25"/>
            <a:stretch/>
          </p:blipFill>
          <p:spPr>
            <a:xfrm>
              <a:off x="330120" y="7251480"/>
              <a:ext cx="319320" cy="164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8" name="文本框 222"/>
            <p:cNvSpPr/>
            <p:nvPr/>
          </p:nvSpPr>
          <p:spPr>
            <a:xfrm>
              <a:off x="1118160" y="7341120"/>
              <a:ext cx="428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9" name="文本框 223"/>
            <p:cNvSpPr/>
            <p:nvPr/>
          </p:nvSpPr>
          <p:spPr>
            <a:xfrm>
              <a:off x="762480" y="8586360"/>
              <a:ext cx="60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690" name="组 227"/>
            <p:cNvGrpSpPr/>
            <p:nvPr/>
          </p:nvGrpSpPr>
          <p:grpSpPr>
            <a:xfrm>
              <a:off x="1022760" y="7524000"/>
              <a:ext cx="438120" cy="34560"/>
              <a:chOff x="1022760" y="7524000"/>
              <a:chExt cx="438120" cy="34560"/>
            </a:xfrm>
          </p:grpSpPr>
          <p:sp>
            <p:nvSpPr>
              <p:cNvPr id="691" name="直线连接符 216"/>
              <p:cNvSpPr/>
              <p:nvPr/>
            </p:nvSpPr>
            <p:spPr>
              <a:xfrm>
                <a:off x="1022760" y="7524000"/>
                <a:ext cx="438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2" name="直线连接符 217"/>
              <p:cNvSpPr/>
              <p:nvPr/>
            </p:nvSpPr>
            <p:spPr>
              <a:xfrm>
                <a:off x="1027080" y="7524000"/>
                <a:ext cx="0" cy="34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3" name="直线连接符 218"/>
              <p:cNvSpPr/>
              <p:nvPr/>
            </p:nvSpPr>
            <p:spPr>
              <a:xfrm>
                <a:off x="1456560" y="7524000"/>
                <a:ext cx="0" cy="34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94" name="文本框 226"/>
            <p:cNvSpPr/>
            <p:nvPr/>
          </p:nvSpPr>
          <p:spPr>
            <a:xfrm>
              <a:off x="1156320" y="8586360"/>
              <a:ext cx="772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95" name="文本框 121" descr=""/>
            <p:cNvPicPr/>
            <p:nvPr/>
          </p:nvPicPr>
          <p:blipFill>
            <a:blip r:embed="rId26"/>
            <a:stretch/>
          </p:blipFill>
          <p:spPr>
            <a:xfrm>
              <a:off x="1699200" y="7205040"/>
              <a:ext cx="319320" cy="1879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6" name="文本框 222"/>
            <p:cNvSpPr/>
            <p:nvPr/>
          </p:nvSpPr>
          <p:spPr>
            <a:xfrm>
              <a:off x="2431800" y="7346880"/>
              <a:ext cx="428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zh-CN" sz="7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**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7" name="文本框 223"/>
            <p:cNvSpPr/>
            <p:nvPr/>
          </p:nvSpPr>
          <p:spPr>
            <a:xfrm>
              <a:off x="2076120" y="8586360"/>
              <a:ext cx="606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698" name="组 227"/>
            <p:cNvGrpSpPr/>
            <p:nvPr/>
          </p:nvGrpSpPr>
          <p:grpSpPr>
            <a:xfrm>
              <a:off x="2336400" y="7529760"/>
              <a:ext cx="438120" cy="34560"/>
              <a:chOff x="2336400" y="7529760"/>
              <a:chExt cx="438120" cy="34560"/>
            </a:xfrm>
          </p:grpSpPr>
          <p:sp>
            <p:nvSpPr>
              <p:cNvPr id="699" name="直线连接符 216"/>
              <p:cNvSpPr/>
              <p:nvPr/>
            </p:nvSpPr>
            <p:spPr>
              <a:xfrm>
                <a:off x="2336400" y="7529760"/>
                <a:ext cx="438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0" name="直线连接符 217"/>
              <p:cNvSpPr/>
              <p:nvPr/>
            </p:nvSpPr>
            <p:spPr>
              <a:xfrm>
                <a:off x="2340720" y="7529760"/>
                <a:ext cx="0" cy="34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1" name="直线连接符 218"/>
              <p:cNvSpPr/>
              <p:nvPr/>
            </p:nvSpPr>
            <p:spPr>
              <a:xfrm>
                <a:off x="2770200" y="7529760"/>
                <a:ext cx="0" cy="34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02" name="组合 173"/>
            <p:cNvGrpSpPr/>
            <p:nvPr/>
          </p:nvGrpSpPr>
          <p:grpSpPr>
            <a:xfrm>
              <a:off x="1787040" y="7429320"/>
              <a:ext cx="385920" cy="1255320"/>
              <a:chOff x="1787040" y="7429320"/>
              <a:chExt cx="385920" cy="1255320"/>
            </a:xfrm>
          </p:grpSpPr>
          <p:sp>
            <p:nvSpPr>
              <p:cNvPr id="703" name="文本框 155"/>
              <p:cNvSpPr/>
              <p:nvPr/>
            </p:nvSpPr>
            <p:spPr>
              <a:xfrm>
                <a:off x="1820520" y="7766280"/>
                <a:ext cx="35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4" name="文本框 156"/>
              <p:cNvSpPr/>
              <p:nvPr/>
            </p:nvSpPr>
            <p:spPr>
              <a:xfrm>
                <a:off x="1820520" y="8117640"/>
                <a:ext cx="35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5" name="文本框 157"/>
              <p:cNvSpPr/>
              <p:nvPr/>
            </p:nvSpPr>
            <p:spPr>
              <a:xfrm>
                <a:off x="1932480" y="8469000"/>
                <a:ext cx="240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6" name="文本框 154"/>
              <p:cNvSpPr/>
              <p:nvPr/>
            </p:nvSpPr>
            <p:spPr>
              <a:xfrm>
                <a:off x="1787040" y="7429320"/>
                <a:ext cx="385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07" name="文本框 226"/>
            <p:cNvSpPr/>
            <p:nvPr/>
          </p:nvSpPr>
          <p:spPr>
            <a:xfrm>
              <a:off x="2469600" y="8586360"/>
              <a:ext cx="772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08" name="文本框 135" descr=""/>
            <p:cNvPicPr/>
            <p:nvPr/>
          </p:nvPicPr>
          <p:blipFill>
            <a:blip r:embed="rId27"/>
            <a:stretch/>
          </p:blipFill>
          <p:spPr>
            <a:xfrm>
              <a:off x="3072600" y="7264080"/>
              <a:ext cx="319320" cy="164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9" name="文本框 222"/>
            <p:cNvSpPr/>
            <p:nvPr/>
          </p:nvSpPr>
          <p:spPr>
            <a:xfrm>
              <a:off x="3844800" y="7395840"/>
              <a:ext cx="428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*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0" name="文本框 223"/>
            <p:cNvSpPr/>
            <p:nvPr/>
          </p:nvSpPr>
          <p:spPr>
            <a:xfrm>
              <a:off x="3489120" y="8586360"/>
              <a:ext cx="60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11" name="组 227"/>
            <p:cNvGrpSpPr/>
            <p:nvPr/>
          </p:nvGrpSpPr>
          <p:grpSpPr>
            <a:xfrm>
              <a:off x="3749760" y="7578720"/>
              <a:ext cx="438120" cy="34920"/>
              <a:chOff x="3749760" y="7578720"/>
              <a:chExt cx="438120" cy="34920"/>
            </a:xfrm>
          </p:grpSpPr>
          <p:sp>
            <p:nvSpPr>
              <p:cNvPr id="712" name="直线连接符 216"/>
              <p:cNvSpPr/>
              <p:nvPr/>
            </p:nvSpPr>
            <p:spPr>
              <a:xfrm>
                <a:off x="3749760" y="7578720"/>
                <a:ext cx="438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3" name="直线连接符 217"/>
              <p:cNvSpPr/>
              <p:nvPr/>
            </p:nvSpPr>
            <p:spPr>
              <a:xfrm>
                <a:off x="3754080" y="7578720"/>
                <a:ext cx="0" cy="34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4" name="直线连接符 218"/>
              <p:cNvSpPr/>
              <p:nvPr/>
            </p:nvSpPr>
            <p:spPr>
              <a:xfrm>
                <a:off x="4183560" y="7578720"/>
                <a:ext cx="0" cy="34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15" name="文本框 226"/>
            <p:cNvSpPr/>
            <p:nvPr/>
          </p:nvSpPr>
          <p:spPr>
            <a:xfrm>
              <a:off x="3882960" y="8586360"/>
              <a:ext cx="772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6" name="文本框 222"/>
            <p:cNvSpPr/>
            <p:nvPr/>
          </p:nvSpPr>
          <p:spPr>
            <a:xfrm>
              <a:off x="5272200" y="7365240"/>
              <a:ext cx="428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*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7" name="文本框 223"/>
            <p:cNvSpPr/>
            <p:nvPr/>
          </p:nvSpPr>
          <p:spPr>
            <a:xfrm>
              <a:off x="4913280" y="8586360"/>
              <a:ext cx="60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18" name="组 227"/>
            <p:cNvGrpSpPr/>
            <p:nvPr/>
          </p:nvGrpSpPr>
          <p:grpSpPr>
            <a:xfrm>
              <a:off x="5173920" y="7553880"/>
              <a:ext cx="438120" cy="34920"/>
              <a:chOff x="5173920" y="7553880"/>
              <a:chExt cx="438120" cy="34920"/>
            </a:xfrm>
          </p:grpSpPr>
          <p:sp>
            <p:nvSpPr>
              <p:cNvPr id="719" name="直线连接符 216"/>
              <p:cNvSpPr/>
              <p:nvPr/>
            </p:nvSpPr>
            <p:spPr>
              <a:xfrm>
                <a:off x="5173920" y="7553880"/>
                <a:ext cx="438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0" name="直线连接符 217"/>
              <p:cNvSpPr/>
              <p:nvPr/>
            </p:nvSpPr>
            <p:spPr>
              <a:xfrm>
                <a:off x="5178240" y="7553880"/>
                <a:ext cx="0" cy="34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1" name="直线连接符 218"/>
              <p:cNvSpPr/>
              <p:nvPr/>
            </p:nvSpPr>
            <p:spPr>
              <a:xfrm>
                <a:off x="5607720" y="7553880"/>
                <a:ext cx="0" cy="34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22" name="文本框 226"/>
            <p:cNvSpPr/>
            <p:nvPr/>
          </p:nvSpPr>
          <p:spPr>
            <a:xfrm>
              <a:off x="5307120" y="8586360"/>
              <a:ext cx="77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23" name="组合 167"/>
            <p:cNvGrpSpPr/>
            <p:nvPr/>
          </p:nvGrpSpPr>
          <p:grpSpPr>
            <a:xfrm>
              <a:off x="446760" y="7428240"/>
              <a:ext cx="386280" cy="1255680"/>
              <a:chOff x="446760" y="7428240"/>
              <a:chExt cx="386280" cy="1255680"/>
            </a:xfrm>
          </p:grpSpPr>
          <p:sp>
            <p:nvSpPr>
              <p:cNvPr id="724" name="文本框 155"/>
              <p:cNvSpPr/>
              <p:nvPr/>
            </p:nvSpPr>
            <p:spPr>
              <a:xfrm>
                <a:off x="480240" y="7677720"/>
                <a:ext cx="352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3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5" name="文本框 156"/>
              <p:cNvSpPr/>
              <p:nvPr/>
            </p:nvSpPr>
            <p:spPr>
              <a:xfrm>
                <a:off x="480240" y="8204760"/>
                <a:ext cx="352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6" name="文本框 157"/>
              <p:cNvSpPr/>
              <p:nvPr/>
            </p:nvSpPr>
            <p:spPr>
              <a:xfrm>
                <a:off x="592200" y="8468280"/>
                <a:ext cx="240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7" name="文本框 154"/>
              <p:cNvSpPr/>
              <p:nvPr/>
            </p:nvSpPr>
            <p:spPr>
              <a:xfrm>
                <a:off x="446760" y="7428240"/>
                <a:ext cx="386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4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8" name="文本框 155"/>
              <p:cNvSpPr/>
              <p:nvPr/>
            </p:nvSpPr>
            <p:spPr>
              <a:xfrm>
                <a:off x="480240" y="7941240"/>
                <a:ext cx="352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2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29" name="组合 174"/>
            <p:cNvGrpSpPr/>
            <p:nvPr/>
          </p:nvGrpSpPr>
          <p:grpSpPr>
            <a:xfrm>
              <a:off x="3196440" y="7433280"/>
              <a:ext cx="385920" cy="1255320"/>
              <a:chOff x="3196440" y="7433280"/>
              <a:chExt cx="385920" cy="1255320"/>
            </a:xfrm>
          </p:grpSpPr>
          <p:sp>
            <p:nvSpPr>
              <p:cNvPr id="730" name="文本框 155"/>
              <p:cNvSpPr/>
              <p:nvPr/>
            </p:nvSpPr>
            <p:spPr>
              <a:xfrm>
                <a:off x="3229920" y="7770240"/>
                <a:ext cx="35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1" name="文本框 156"/>
              <p:cNvSpPr/>
              <p:nvPr/>
            </p:nvSpPr>
            <p:spPr>
              <a:xfrm>
                <a:off x="3229920" y="8121600"/>
                <a:ext cx="35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2" name="文本框 157"/>
              <p:cNvSpPr/>
              <p:nvPr/>
            </p:nvSpPr>
            <p:spPr>
              <a:xfrm>
                <a:off x="3341880" y="8472960"/>
                <a:ext cx="240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3" name="文本框 154"/>
              <p:cNvSpPr/>
              <p:nvPr/>
            </p:nvSpPr>
            <p:spPr>
              <a:xfrm>
                <a:off x="3196440" y="7433280"/>
                <a:ext cx="385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34" name="组合 179"/>
            <p:cNvGrpSpPr/>
            <p:nvPr/>
          </p:nvGrpSpPr>
          <p:grpSpPr>
            <a:xfrm>
              <a:off x="4616640" y="7430040"/>
              <a:ext cx="385920" cy="1255320"/>
              <a:chOff x="4616640" y="7430040"/>
              <a:chExt cx="385920" cy="1255320"/>
            </a:xfrm>
          </p:grpSpPr>
          <p:sp>
            <p:nvSpPr>
              <p:cNvPr id="735" name="文本框 155"/>
              <p:cNvSpPr/>
              <p:nvPr/>
            </p:nvSpPr>
            <p:spPr>
              <a:xfrm>
                <a:off x="4650120" y="7767000"/>
                <a:ext cx="35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6" name="文本框 156"/>
              <p:cNvSpPr/>
              <p:nvPr/>
            </p:nvSpPr>
            <p:spPr>
              <a:xfrm>
                <a:off x="4650120" y="8118360"/>
                <a:ext cx="352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7" name="文本框 157"/>
              <p:cNvSpPr/>
              <p:nvPr/>
            </p:nvSpPr>
            <p:spPr>
              <a:xfrm>
                <a:off x="4762080" y="8469720"/>
                <a:ext cx="240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8" name="文本框 154"/>
              <p:cNvSpPr/>
              <p:nvPr/>
            </p:nvSpPr>
            <p:spPr>
              <a:xfrm>
                <a:off x="4616640" y="7430040"/>
                <a:ext cx="385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1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739" name="文本框 184" descr=""/>
            <p:cNvPicPr/>
            <p:nvPr/>
          </p:nvPicPr>
          <p:blipFill>
            <a:blip r:embed="rId28"/>
            <a:stretch/>
          </p:blipFill>
          <p:spPr>
            <a:xfrm>
              <a:off x="4537440" y="7013520"/>
              <a:ext cx="319320" cy="2136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0" name="文本框 208"/>
            <p:cNvSpPr/>
            <p:nvPr/>
          </p:nvSpPr>
          <p:spPr>
            <a:xfrm>
              <a:off x="2385720" y="8827920"/>
              <a:ext cx="1221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Chemical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defined</a:t>
              </a: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yste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41" name="文本框 121"/>
          <p:cNvSpPr/>
          <p:nvPr/>
        </p:nvSpPr>
        <p:spPr>
          <a:xfrm>
            <a:off x="2293920" y="6894360"/>
            <a:ext cx="1393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mAGM-S3 co-culture syste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2-02T00:09:00Z</dcterms:created>
  <dc:creator>yu wang</dc:creator>
  <dc:description/>
  <dc:language>en-US</dc:language>
  <cp:lastModifiedBy>yuwang</cp:lastModifiedBy>
  <dcterms:modified xsi:type="dcterms:W3CDTF">2019-03-26T23:57:11Z</dcterms:modified>
  <cp:revision>258</cp:revision>
  <dc:subject/>
  <dc:title>PowerPoint ʾĸ�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.0.0.1087</vt:lpwstr>
  </property>
</Properties>
</file>